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5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6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7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8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9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2.xml" ContentType="application/vnd.openxmlformats-officedocument.presentationml.notesSlide+xml"/>
  <Override PartName="/ppt/charts/chart10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notesSlides/notesSlide3.xml" ContentType="application/vnd.openxmlformats-officedocument.presentationml.notesSlide+xml"/>
  <Override PartName="/ppt/charts/chart11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4"/>
  </p:notesMasterIdLst>
  <p:sldIdLst>
    <p:sldId id="306" r:id="rId2"/>
    <p:sldId id="385" r:id="rId3"/>
    <p:sldId id="311" r:id="rId4"/>
    <p:sldId id="384" r:id="rId5"/>
    <p:sldId id="383" r:id="rId6"/>
    <p:sldId id="326" r:id="rId7"/>
    <p:sldId id="381" r:id="rId8"/>
    <p:sldId id="379" r:id="rId9"/>
    <p:sldId id="376" r:id="rId10"/>
    <p:sldId id="359" r:id="rId11"/>
    <p:sldId id="269" r:id="rId12"/>
    <p:sldId id="361" r:id="rId13"/>
    <p:sldId id="262" r:id="rId14"/>
    <p:sldId id="358" r:id="rId15"/>
    <p:sldId id="356" r:id="rId16"/>
    <p:sldId id="357" r:id="rId17"/>
    <p:sldId id="387" r:id="rId18"/>
    <p:sldId id="382" r:id="rId19"/>
    <p:sldId id="386" r:id="rId20"/>
    <p:sldId id="346" r:id="rId21"/>
    <p:sldId id="368" r:id="rId22"/>
    <p:sldId id="369" r:id="rId2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50021"/>
    <a:srgbClr val="0000FF"/>
    <a:srgbClr val="006600"/>
    <a:srgbClr val="CC00FF"/>
    <a:srgbClr val="3333FF"/>
    <a:srgbClr val="CC0099"/>
    <a:srgbClr val="CC00CC"/>
    <a:srgbClr val="CC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546" autoAdjust="0"/>
    <p:restoredTop sz="95758" autoAdjust="0"/>
  </p:normalViewPr>
  <p:slideViewPr>
    <p:cSldViewPr snapToGrid="0">
      <p:cViewPr varScale="1">
        <p:scale>
          <a:sx n="82" d="100"/>
          <a:sy n="82" d="100"/>
        </p:scale>
        <p:origin x="878" y="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&#35770;&#25991;\&#40644;&#40635;&#22522;&#22240;&#32452;\&#40644;&#40635;&#20892;&#33402;&#24615;&#29366;-&#30452;&#26041;&#22270;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esktop\&#40644;&#40635;CcCOBRA&#22522;&#22240;&#23478;&#26063;&#30005;&#23376;&#34920;&#36798;&#37327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\&#30740;&#31350;&#29983;\&#32418;&#40644;&#40635;&#22522;&#22240;&#32452;\&#40644;&#40635;&#22522;&#22240;&#32452;&#35770;&#25991;190624\Fig.%206&#32420;&#32500;&#21697;&#36136;&#30456;&#20851;&#22522;&#22240;\&#32420;&#32500;&#32032;&#20851;&#32852;&#22522;&#22240;C4H\SNP-Cc.07G0016270.%20C4H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&#35770;&#25991;\&#40644;&#40635;&#22522;&#22240;&#32452;\&#40644;&#40635;&#20892;&#33402;&#24615;&#29366;-&#30452;&#26041;&#22270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&#35770;&#25991;\&#40644;&#40635;&#22522;&#22240;&#32452;\&#40644;&#40635;&#20892;&#33402;&#24615;&#29366;-&#30452;&#26041;&#22270;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esktop\&#20998;&#26525;&#25968;;&#20998;&#26525;&#39640;;&#33410;&#25968;;&#32420;&#32500;&#32454;&#24230;;&#26408;&#36136;&#32032;-&#30452;&#26041;&#22270;(2016,2017,2018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esktop\&#20998;&#26525;&#25968;;&#20998;&#26525;&#39640;;&#33410;&#25968;;&#32420;&#32500;&#32454;&#24230;;&#26408;&#36136;&#32032;-&#30452;&#26041;&#22270;(2016,2017,2018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esktop\&#20998;&#26525;&#25968;;&#20998;&#26525;&#39640;;&#33410;&#25968;;&#32420;&#32500;&#32454;&#24230;;&#26408;&#36136;&#32032;-&#30452;&#26041;&#22270;(2016,2017,2018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esktop\&#20998;&#26525;&#25968;;&#20998;&#26525;&#39640;;&#33410;&#25968;;&#32420;&#32500;&#32454;&#24230;;&#26408;&#36136;&#32032;-&#30452;&#26041;&#22270;(2016,2017,2018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esktop\&#20998;&#26525;&#25968;;&#20998;&#26525;&#39640;;&#33410;&#25968;;&#32420;&#32500;&#32454;&#24230;;&#26408;&#36136;&#32032;-&#30452;&#26041;&#22270;(2016,2017,2018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esktop\&#20998;&#26525;&#25968;;&#20998;&#26525;&#39640;;&#33410;&#25968;;&#32420;&#32500;&#32454;&#24230;;&#26408;&#36136;&#32032;-&#30452;&#26041;&#22270;(2016,2017,2018)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u="none" strike="noStrike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ellulose content </a:t>
            </a:r>
            <a:r>
              <a:rPr lang="en-US" altLang="zh-CN" sz="1400" b="0" i="0" u="none" strike="noStrike" baseline="0" dirty="0">
                <a:effectLst/>
              </a:rPr>
              <a:t>(%) </a:t>
            </a: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2016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纤维素含量!$N$2:$N$6</c:f>
              <c:strCache>
                <c:ptCount val="5"/>
                <c:pt idx="0">
                  <c:v>30-35</c:v>
                </c:pt>
                <c:pt idx="1">
                  <c:v>35-40</c:v>
                </c:pt>
                <c:pt idx="2">
                  <c:v>40-45</c:v>
                </c:pt>
                <c:pt idx="3">
                  <c:v>45-50</c:v>
                </c:pt>
                <c:pt idx="4">
                  <c:v>&gt;50</c:v>
                </c:pt>
              </c:strCache>
            </c:strRef>
          </c:cat>
          <c:val>
            <c:numRef>
              <c:f>纤维素含量!$O$2:$O$6</c:f>
              <c:numCache>
                <c:formatCode>General</c:formatCode>
                <c:ptCount val="5"/>
                <c:pt idx="0">
                  <c:v>3</c:v>
                </c:pt>
                <c:pt idx="1">
                  <c:v>7</c:v>
                </c:pt>
                <c:pt idx="2">
                  <c:v>18</c:v>
                </c:pt>
                <c:pt idx="3">
                  <c:v>8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90-4809-B3D4-832EA945D6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8505088"/>
        <c:axId val="98506624"/>
      </c:barChart>
      <c:catAx>
        <c:axId val="985050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98506624"/>
        <c:crosses val="autoZero"/>
        <c:auto val="1"/>
        <c:lblAlgn val="ctr"/>
        <c:lblOffset val="100"/>
        <c:noMultiLvlLbl val="0"/>
      </c:catAx>
      <c:valAx>
        <c:axId val="985066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050" b="0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accessions</a:t>
                </a:r>
                <a:endParaRPr lang="zh-CN" altLang="zh-CN" sz="105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98505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sz="1400" b="0" i="1" u="none" strike="noStrike" baseline="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COBRA1</a:t>
            </a:r>
            <a:endParaRPr lang="en-US" altLang="zh-CN" i="1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cCOBRA基因家族的电子表达模式!$I$6</c:f>
              <c:strCache>
                <c:ptCount val="1"/>
                <c:pt idx="0">
                  <c:v>CcCOBR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dLbl>
              <c:idx val="1"/>
              <c:tx>
                <c:rich>
                  <a:bodyPr/>
                  <a:lstStyle/>
                  <a:p>
                    <a:r>
                      <a:rPr lang="en-US" altLang="zh-CN" dirty="0"/>
                      <a:t>*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7A06-4922-995D-B1FBD9011B6A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 altLang="zh-CN" dirty="0">
                        <a:solidFill>
                          <a:schemeClr val="tx1"/>
                        </a:solidFill>
                      </a:rPr>
                      <a:t>*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7A06-4922-995D-B1FBD9011B6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cCOBRA基因家族的电子表达模式!$J$5:$L$5</c:f>
              <c:strCache>
                <c:ptCount val="3"/>
                <c:pt idx="0">
                  <c:v>Seedling stage</c:v>
                </c:pt>
                <c:pt idx="1">
                  <c:v>Vigorous growth stage</c:v>
                </c:pt>
                <c:pt idx="2">
                  <c:v>Technology maturity stage</c:v>
                </c:pt>
              </c:strCache>
            </c:strRef>
          </c:cat>
          <c:val>
            <c:numRef>
              <c:f>CcCOBRA基因家族的电子表达模式!$J$6:$L$6</c:f>
              <c:numCache>
                <c:formatCode>General</c:formatCode>
                <c:ptCount val="3"/>
                <c:pt idx="0">
                  <c:v>0.87184364850931773</c:v>
                </c:pt>
                <c:pt idx="1">
                  <c:v>1.9781956296816519</c:v>
                </c:pt>
                <c:pt idx="2">
                  <c:v>2.64154602908751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A06-4922-995D-B1FBD9011B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4676480"/>
        <c:axId val="460291728"/>
      </c:barChart>
      <c:catAx>
        <c:axId val="4546764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60291728"/>
        <c:crosses val="autoZero"/>
        <c:auto val="1"/>
        <c:lblAlgn val="ctr"/>
        <c:lblOffset val="100"/>
        <c:noMultiLvlLbl val="0"/>
      </c:catAx>
      <c:valAx>
        <c:axId val="4602917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20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US" altLang="zh-CN" sz="120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expression</a:t>
                </a:r>
                <a:endParaRPr lang="zh-CN" altLang="en-US" sz="120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546764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R$18</c:f>
              <c:strCache>
                <c:ptCount val="1"/>
                <c:pt idx="0">
                  <c:v>CcC4H1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1"/>
              <c:tx>
                <c:rich>
                  <a:bodyPr/>
                  <a:lstStyle/>
                  <a:p>
                    <a:r>
                      <a:rPr lang="en-US" altLang="zh-CN" sz="2800" dirty="0">
                        <a:solidFill>
                          <a:schemeClr val="tx1"/>
                        </a:solidFill>
                      </a:rPr>
                      <a:t>*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1247-4810-9454-EE57F66BBA6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percentage"/>
            <c:noEndCap val="0"/>
            <c:val val="5"/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S$17:$T$17</c:f>
              <c:strCache>
                <c:ptCount val="2"/>
                <c:pt idx="0">
                  <c:v>leaves</c:v>
                </c:pt>
                <c:pt idx="1">
                  <c:v> stem bark</c:v>
                </c:pt>
              </c:strCache>
            </c:strRef>
          </c:cat>
          <c:val>
            <c:numRef>
              <c:f>Sheet2!$S$18:$T$18</c:f>
              <c:numCache>
                <c:formatCode>General</c:formatCode>
                <c:ptCount val="2"/>
                <c:pt idx="0">
                  <c:v>1.7527485914071339</c:v>
                </c:pt>
                <c:pt idx="1">
                  <c:v>5.65621032018259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247-4810-9454-EE57F66BBA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1808223"/>
        <c:axId val="512031663"/>
      </c:barChart>
      <c:catAx>
        <c:axId val="40180822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12031663"/>
        <c:crosses val="autoZero"/>
        <c:auto val="1"/>
        <c:lblAlgn val="ctr"/>
        <c:lblOffset val="100"/>
        <c:noMultiLvlLbl val="0"/>
      </c:catAx>
      <c:valAx>
        <c:axId val="51203166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200" b="0" i="0" baseline="0">
                    <a:solidFill>
                      <a:sysClr val="windowText" lastClr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</a:t>
                </a:r>
                <a:endParaRPr lang="zh-CN" altLang="zh-CN" sz="1200">
                  <a:solidFill>
                    <a:sysClr val="windowText" lastClr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018082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algn="ctr" rtl="0">
              <a:defRPr lang="zh-CN" altLang="en-US"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u="none" strike="noStrike" kern="1200" spc="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ellulose content </a:t>
            </a:r>
            <a:r>
              <a:rPr lang="en-US" altLang="zh-CN" sz="1400" b="0" i="0" u="none" strike="noStrike" baseline="0" dirty="0">
                <a:effectLst/>
              </a:rPr>
              <a:t>(%) </a:t>
            </a:r>
            <a:r>
              <a:rPr lang="zh-CN" altLang="en-US" sz="1400" b="0" i="0" u="none" strike="noStrike" kern="1200" spc="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-</a:t>
            </a:r>
            <a:r>
              <a:rPr lang="en-US" altLang="zh-CN" sz="1400" b="0" i="0" u="none" strike="noStrike" kern="1200" spc="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0</a:t>
            </a:r>
            <a:r>
              <a:rPr lang="zh-CN" altLang="en-US" sz="1400" b="0" i="0" u="none" strike="noStrike" kern="1200" spc="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7 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cat>
            <c:strRef>
              <c:f>纤维素含量!$F$2:$F$6</c:f>
              <c:strCache>
                <c:ptCount val="5"/>
                <c:pt idx="0">
                  <c:v>20-30</c:v>
                </c:pt>
                <c:pt idx="1">
                  <c:v>30-40</c:v>
                </c:pt>
                <c:pt idx="2">
                  <c:v>40-50</c:v>
                </c:pt>
                <c:pt idx="3">
                  <c:v>50-60</c:v>
                </c:pt>
                <c:pt idx="4">
                  <c:v>&gt;60</c:v>
                </c:pt>
              </c:strCache>
            </c:strRef>
          </c:cat>
          <c:val>
            <c:numRef>
              <c:f>纤维素含量!$G$2:$G$6</c:f>
              <c:numCache>
                <c:formatCode>General</c:formatCode>
                <c:ptCount val="5"/>
                <c:pt idx="0">
                  <c:v>16</c:v>
                </c:pt>
                <c:pt idx="1">
                  <c:v>83</c:v>
                </c:pt>
                <c:pt idx="2">
                  <c:v>79</c:v>
                </c:pt>
                <c:pt idx="3">
                  <c:v>21</c:v>
                </c:pt>
                <c:pt idx="4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60-4ABC-883C-9EF108BF56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8540544"/>
        <c:axId val="98542336"/>
      </c:barChart>
      <c:catAx>
        <c:axId val="985405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/>
          </a:p>
        </c:txPr>
        <c:crossAx val="98542336"/>
        <c:crosses val="autoZero"/>
        <c:auto val="1"/>
        <c:lblAlgn val="ctr"/>
        <c:lblOffset val="100"/>
        <c:noMultiLvlLbl val="0"/>
      </c:catAx>
      <c:valAx>
        <c:axId val="9854233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zh-CN" sz="105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accessions</a:t>
                </a:r>
                <a:endParaRPr lang="zh-CN" altLang="zh-CN" sz="105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/>
          </a:p>
        </c:txPr>
        <c:crossAx val="985405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 algn="ctr" rtl="0">
              <a:defRPr lang="zh-CN" altLang="en-US"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u="none" strike="noStrike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ellulose content </a:t>
            </a:r>
            <a:r>
              <a:rPr lang="en-US" altLang="zh-CN" sz="1400" b="0" i="0" u="none" strike="noStrike" baseline="0" dirty="0">
                <a:effectLst/>
              </a:rPr>
              <a:t>(%) </a:t>
            </a:r>
            <a:r>
              <a:rPr lang="zh-CN" altLang="en-US" sz="1400" b="0" i="0" u="none" strike="noStrike" kern="1200" spc="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-</a:t>
            </a:r>
            <a:r>
              <a:rPr lang="en-US" altLang="zh-CN" sz="1400" b="0" i="0" u="none" strike="noStrike" kern="1200" spc="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018</a:t>
            </a:r>
            <a:r>
              <a:rPr lang="zh-CN" altLang="en-US" sz="1400" b="0" i="0" u="none" strike="noStrike" kern="1200" spc="0" baseline="0" dirty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cat>
            <c:strRef>
              <c:f>纤维素含量!$B$2:$B$8</c:f>
              <c:strCache>
                <c:ptCount val="7"/>
                <c:pt idx="0">
                  <c:v>40-45</c:v>
                </c:pt>
                <c:pt idx="1">
                  <c:v>45-50</c:v>
                </c:pt>
                <c:pt idx="2">
                  <c:v>50-55</c:v>
                </c:pt>
                <c:pt idx="3">
                  <c:v>55-60</c:v>
                </c:pt>
                <c:pt idx="4">
                  <c:v>60-65</c:v>
                </c:pt>
                <c:pt idx="5">
                  <c:v>65-70</c:v>
                </c:pt>
                <c:pt idx="6">
                  <c:v>&gt;70</c:v>
                </c:pt>
              </c:strCache>
            </c:strRef>
          </c:cat>
          <c:val>
            <c:numRef>
              <c:f>纤维素含量!$C$2:$C$8</c:f>
              <c:numCache>
                <c:formatCode>General</c:formatCode>
                <c:ptCount val="7"/>
                <c:pt idx="0">
                  <c:v>12</c:v>
                </c:pt>
                <c:pt idx="1">
                  <c:v>53</c:v>
                </c:pt>
                <c:pt idx="2">
                  <c:v>47</c:v>
                </c:pt>
                <c:pt idx="3">
                  <c:v>41</c:v>
                </c:pt>
                <c:pt idx="4">
                  <c:v>15</c:v>
                </c:pt>
                <c:pt idx="5">
                  <c:v>6</c:v>
                </c:pt>
                <c:pt idx="6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09A-4395-B720-C40B6AF9FB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8564736"/>
        <c:axId val="98832768"/>
      </c:barChart>
      <c:catAx>
        <c:axId val="985647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/>
          </a:p>
        </c:txPr>
        <c:crossAx val="98832768"/>
        <c:crosses val="autoZero"/>
        <c:auto val="1"/>
        <c:lblAlgn val="ctr"/>
        <c:lblOffset val="100"/>
        <c:noMultiLvlLbl val="0"/>
      </c:catAx>
      <c:valAx>
        <c:axId val="9883276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zh-CN" sz="1050" b="0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accessions</a:t>
                </a:r>
                <a:endParaRPr lang="zh-CN" altLang="zh-CN" sz="105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/>
          </a:p>
        </c:txPr>
        <c:crossAx val="985647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gnin content (%)- 2016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木质素含量!$B$2:$B$9</c:f>
              <c:strCache>
                <c:ptCount val="8"/>
                <c:pt idx="0">
                  <c:v>6-8</c:v>
                </c:pt>
                <c:pt idx="1">
                  <c:v>8-10</c:v>
                </c:pt>
                <c:pt idx="2">
                  <c:v>10-12</c:v>
                </c:pt>
                <c:pt idx="3">
                  <c:v>12-14</c:v>
                </c:pt>
                <c:pt idx="4">
                  <c:v>14-16</c:v>
                </c:pt>
                <c:pt idx="5">
                  <c:v>16-18</c:v>
                </c:pt>
                <c:pt idx="6">
                  <c:v>18-20</c:v>
                </c:pt>
                <c:pt idx="7">
                  <c:v>&gt;20</c:v>
                </c:pt>
              </c:strCache>
            </c:strRef>
          </c:cat>
          <c:val>
            <c:numRef>
              <c:f>木质素含量!$C$2:$C$9</c:f>
              <c:numCache>
                <c:formatCode>0.00_);[Red]\(0.00\)</c:formatCode>
                <c:ptCount val="8"/>
                <c:pt idx="0">
                  <c:v>1</c:v>
                </c:pt>
                <c:pt idx="1">
                  <c:v>26</c:v>
                </c:pt>
                <c:pt idx="2">
                  <c:v>69</c:v>
                </c:pt>
                <c:pt idx="3">
                  <c:v>56</c:v>
                </c:pt>
                <c:pt idx="4">
                  <c:v>13</c:v>
                </c:pt>
                <c:pt idx="5">
                  <c:v>10</c:v>
                </c:pt>
                <c:pt idx="6">
                  <c:v>2</c:v>
                </c:pt>
                <c:pt idx="7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456-48D1-BCFC-925CC7246F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784688"/>
        <c:axId val="577060112"/>
      </c:barChart>
      <c:catAx>
        <c:axId val="404784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77060112"/>
        <c:crosses val="autoZero"/>
        <c:auto val="1"/>
        <c:lblAlgn val="ctr"/>
        <c:lblOffset val="100"/>
        <c:noMultiLvlLbl val="0"/>
      </c:catAx>
      <c:valAx>
        <c:axId val="5770601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05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accessions</a:t>
                </a:r>
                <a:endParaRPr lang="zh-CN" altLang="en-US" sz="10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0.00_);[Red]\(0.00\)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04784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gnin content </a:t>
            </a:r>
            <a:r>
              <a:rPr lang="en-US" altLang="zh-CN" sz="1400" b="0" i="0" u="none" strike="noStrike" baseline="0" dirty="0">
                <a:effectLst/>
              </a:rPr>
              <a:t>(%)</a:t>
            </a: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2017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木质素含量!$F$2:$F$6</c:f>
              <c:strCache>
                <c:ptCount val="5"/>
                <c:pt idx="0">
                  <c:v>6-8</c:v>
                </c:pt>
                <c:pt idx="1">
                  <c:v>8-10</c:v>
                </c:pt>
                <c:pt idx="2">
                  <c:v>10-12</c:v>
                </c:pt>
                <c:pt idx="3">
                  <c:v>12-14</c:v>
                </c:pt>
                <c:pt idx="4">
                  <c:v>14-16</c:v>
                </c:pt>
              </c:strCache>
            </c:strRef>
          </c:cat>
          <c:val>
            <c:numRef>
              <c:f>木质素含量!$G$2:$G$6</c:f>
              <c:numCache>
                <c:formatCode>General</c:formatCode>
                <c:ptCount val="5"/>
                <c:pt idx="0">
                  <c:v>35</c:v>
                </c:pt>
                <c:pt idx="1">
                  <c:v>117</c:v>
                </c:pt>
                <c:pt idx="2">
                  <c:v>41</c:v>
                </c:pt>
                <c:pt idx="3">
                  <c:v>9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37C-4310-A49D-855CF44F42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784688"/>
        <c:axId val="577060112"/>
      </c:barChart>
      <c:catAx>
        <c:axId val="404784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77060112"/>
        <c:crosses val="autoZero"/>
        <c:auto val="1"/>
        <c:lblAlgn val="ctr"/>
        <c:lblOffset val="100"/>
        <c:noMultiLvlLbl val="0"/>
      </c:catAx>
      <c:valAx>
        <c:axId val="5770601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05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accessions</a:t>
                </a:r>
                <a:endParaRPr lang="zh-CN" altLang="en-US" sz="10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04784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gnin content </a:t>
            </a:r>
            <a:r>
              <a:rPr lang="en-US" altLang="zh-CN" sz="1400" b="0" i="0" u="none" strike="noStrike" baseline="0" dirty="0">
                <a:effectLst/>
              </a:rPr>
              <a:t>(%) </a:t>
            </a: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2018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木质素含量!$N$2:$N$7</c:f>
              <c:strCache>
                <c:ptCount val="6"/>
                <c:pt idx="0">
                  <c:v>6-8</c:v>
                </c:pt>
                <c:pt idx="1">
                  <c:v>8-10</c:v>
                </c:pt>
                <c:pt idx="2">
                  <c:v>10-12</c:v>
                </c:pt>
                <c:pt idx="3">
                  <c:v>12-14</c:v>
                </c:pt>
                <c:pt idx="4">
                  <c:v>14-16</c:v>
                </c:pt>
                <c:pt idx="5">
                  <c:v>16-18</c:v>
                </c:pt>
              </c:strCache>
            </c:strRef>
          </c:cat>
          <c:val>
            <c:numRef>
              <c:f>木质素含量!$O$2:$O$7</c:f>
              <c:numCache>
                <c:formatCode>General</c:formatCode>
                <c:ptCount val="6"/>
                <c:pt idx="0">
                  <c:v>44</c:v>
                </c:pt>
                <c:pt idx="1">
                  <c:v>99</c:v>
                </c:pt>
                <c:pt idx="2">
                  <c:v>50</c:v>
                </c:pt>
                <c:pt idx="3">
                  <c:v>8</c:v>
                </c:pt>
                <c:pt idx="4">
                  <c:v>9</c:v>
                </c:pt>
                <c:pt idx="5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68-4830-888A-4B14938784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784688"/>
        <c:axId val="577060112"/>
      </c:barChart>
      <c:catAx>
        <c:axId val="404784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77060112"/>
        <c:crosses val="autoZero"/>
        <c:auto val="1"/>
        <c:lblAlgn val="ctr"/>
        <c:lblOffset val="100"/>
        <c:noMultiLvlLbl val="0"/>
      </c:catAx>
      <c:valAx>
        <c:axId val="5770601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05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accessions</a:t>
                </a:r>
                <a:endParaRPr lang="zh-CN" altLang="en-US" sz="105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04784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bre</a:t>
            </a: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ineness </a:t>
            </a:r>
            <a:r>
              <a:rPr lang="en-US" altLang="zh-CN" sz="1400" b="0" i="0" u="none" strike="noStrike" baseline="0" dirty="0">
                <a:solidFill>
                  <a:schemeClr val="tx1"/>
                </a:solidFill>
                <a:effectLst/>
              </a:rPr>
              <a:t>(</a:t>
            </a:r>
            <a:r>
              <a:rPr lang="en-US" altLang="zh-CN" sz="1400" b="0" i="0" u="none" strike="noStrike" baseline="0" dirty="0" err="1">
                <a:solidFill>
                  <a:schemeClr val="tx1"/>
                </a:solidFill>
                <a:effectLst/>
              </a:rPr>
              <a:t>Tex</a:t>
            </a:r>
            <a:r>
              <a:rPr lang="en-US" altLang="zh-CN" sz="1400" b="0" i="0" u="none" strike="noStrike" baseline="0" dirty="0">
                <a:solidFill>
                  <a:schemeClr val="tx1"/>
                </a:solidFill>
                <a:effectLst/>
              </a:rPr>
              <a:t>) </a:t>
            </a: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2017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纤维细度!$S$6:$S$12</c:f>
              <c:strCache>
                <c:ptCount val="7"/>
                <c:pt idx="0">
                  <c:v>&lt;250</c:v>
                </c:pt>
                <c:pt idx="1">
                  <c:v>250-300</c:v>
                </c:pt>
                <c:pt idx="2">
                  <c:v>300-350</c:v>
                </c:pt>
                <c:pt idx="3">
                  <c:v>350-400</c:v>
                </c:pt>
                <c:pt idx="4">
                  <c:v>400-450</c:v>
                </c:pt>
                <c:pt idx="5">
                  <c:v>450-500</c:v>
                </c:pt>
                <c:pt idx="6">
                  <c:v>&gt;500</c:v>
                </c:pt>
              </c:strCache>
            </c:strRef>
          </c:cat>
          <c:val>
            <c:numRef>
              <c:f>纤维细度!$T$6:$T$12</c:f>
              <c:numCache>
                <c:formatCode>General</c:formatCode>
                <c:ptCount val="7"/>
                <c:pt idx="0">
                  <c:v>2</c:v>
                </c:pt>
                <c:pt idx="1">
                  <c:v>18</c:v>
                </c:pt>
                <c:pt idx="2">
                  <c:v>24</c:v>
                </c:pt>
                <c:pt idx="3">
                  <c:v>25</c:v>
                </c:pt>
                <c:pt idx="4">
                  <c:v>43</c:v>
                </c:pt>
                <c:pt idx="5">
                  <c:v>18</c:v>
                </c:pt>
                <c:pt idx="6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48-40D8-B9E1-991A68A7F9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784688"/>
        <c:axId val="577060112"/>
      </c:barChart>
      <c:catAx>
        <c:axId val="404784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77060112"/>
        <c:crosses val="autoZero"/>
        <c:auto val="1"/>
        <c:lblAlgn val="ctr"/>
        <c:lblOffset val="100"/>
        <c:noMultiLvlLbl val="0"/>
      </c:catAx>
      <c:valAx>
        <c:axId val="5770601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05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accessions</a:t>
                </a:r>
                <a:endParaRPr lang="zh-CN" altLang="en-US" sz="105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04784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bre</a:t>
            </a: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ineness</a:t>
            </a:r>
            <a:r>
              <a:rPr lang="en-US" altLang="zh-CN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zh-CN" baseline="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x</a:t>
            </a:r>
            <a:r>
              <a:rPr lang="en-US" altLang="zh-CN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- 2016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纤维细度!$Q$6:$Q$12</c:f>
              <c:strCache>
                <c:ptCount val="7"/>
                <c:pt idx="0">
                  <c:v>&lt;250</c:v>
                </c:pt>
                <c:pt idx="1">
                  <c:v>250-300</c:v>
                </c:pt>
                <c:pt idx="2">
                  <c:v>300-350</c:v>
                </c:pt>
                <c:pt idx="3">
                  <c:v>350-400</c:v>
                </c:pt>
                <c:pt idx="4">
                  <c:v>400-450</c:v>
                </c:pt>
                <c:pt idx="5">
                  <c:v>450-500</c:v>
                </c:pt>
                <c:pt idx="6">
                  <c:v>&gt;500</c:v>
                </c:pt>
              </c:strCache>
            </c:strRef>
          </c:cat>
          <c:val>
            <c:numRef>
              <c:f>纤维细度!$R$6:$R$12</c:f>
              <c:numCache>
                <c:formatCode>General</c:formatCode>
                <c:ptCount val="7"/>
                <c:pt idx="0">
                  <c:v>1</c:v>
                </c:pt>
                <c:pt idx="1">
                  <c:v>18</c:v>
                </c:pt>
                <c:pt idx="2">
                  <c:v>25</c:v>
                </c:pt>
                <c:pt idx="3">
                  <c:v>24</c:v>
                </c:pt>
                <c:pt idx="4">
                  <c:v>44</c:v>
                </c:pt>
                <c:pt idx="5">
                  <c:v>18</c:v>
                </c:pt>
                <c:pt idx="6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2B-4E0E-A555-EAB7066BD7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784688"/>
        <c:axId val="577060112"/>
      </c:barChart>
      <c:catAx>
        <c:axId val="404784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77060112"/>
        <c:crosses val="autoZero"/>
        <c:auto val="1"/>
        <c:lblAlgn val="ctr"/>
        <c:lblOffset val="100"/>
        <c:noMultiLvlLbl val="0"/>
      </c:catAx>
      <c:valAx>
        <c:axId val="5770601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05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accessions</a:t>
                </a:r>
                <a:endParaRPr lang="zh-CN" altLang="en-US" sz="105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04784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bre</a:t>
            </a: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ineness </a:t>
            </a:r>
            <a:r>
              <a:rPr lang="en-US" altLang="zh-CN" sz="1400" b="0" i="0" u="none" strike="noStrike" baseline="0" dirty="0">
                <a:solidFill>
                  <a:schemeClr val="tx1"/>
                </a:solidFill>
                <a:effectLst/>
              </a:rPr>
              <a:t>(</a:t>
            </a:r>
            <a:r>
              <a:rPr lang="en-US" altLang="zh-CN" sz="1400" b="0" i="0" u="none" strike="noStrike" baseline="0" dirty="0" err="1">
                <a:solidFill>
                  <a:schemeClr val="tx1"/>
                </a:solidFill>
                <a:effectLst/>
              </a:rPr>
              <a:t>Tex</a:t>
            </a:r>
            <a:r>
              <a:rPr lang="en-US" altLang="zh-CN" sz="1400" b="0" i="0" u="none" strike="noStrike" baseline="0" dirty="0">
                <a:solidFill>
                  <a:schemeClr val="tx1"/>
                </a:solidFill>
                <a:effectLst/>
              </a:rPr>
              <a:t>) </a:t>
            </a: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- 2018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纤维细度!$U$6:$U$12</c:f>
              <c:strCache>
                <c:ptCount val="7"/>
                <c:pt idx="0">
                  <c:v>&lt;250</c:v>
                </c:pt>
                <c:pt idx="1">
                  <c:v>250-300</c:v>
                </c:pt>
                <c:pt idx="2">
                  <c:v>300-350</c:v>
                </c:pt>
                <c:pt idx="3">
                  <c:v>350-400</c:v>
                </c:pt>
                <c:pt idx="4">
                  <c:v>400-450</c:v>
                </c:pt>
                <c:pt idx="5">
                  <c:v>450-500</c:v>
                </c:pt>
                <c:pt idx="6">
                  <c:v>&gt;500</c:v>
                </c:pt>
              </c:strCache>
            </c:strRef>
          </c:cat>
          <c:val>
            <c:numRef>
              <c:f>纤维细度!$V$6:$V$12</c:f>
              <c:numCache>
                <c:formatCode>General</c:formatCode>
                <c:ptCount val="7"/>
                <c:pt idx="0">
                  <c:v>2</c:v>
                </c:pt>
                <c:pt idx="1">
                  <c:v>19</c:v>
                </c:pt>
                <c:pt idx="2">
                  <c:v>23</c:v>
                </c:pt>
                <c:pt idx="3">
                  <c:v>26</c:v>
                </c:pt>
                <c:pt idx="4">
                  <c:v>43</c:v>
                </c:pt>
                <c:pt idx="5">
                  <c:v>17</c:v>
                </c:pt>
                <c:pt idx="6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16-443E-AF06-CAAB0F103F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4784688"/>
        <c:axId val="577060112"/>
      </c:barChart>
      <c:catAx>
        <c:axId val="404784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77060112"/>
        <c:crosses val="autoZero"/>
        <c:auto val="1"/>
        <c:lblAlgn val="ctr"/>
        <c:lblOffset val="100"/>
        <c:noMultiLvlLbl val="0"/>
      </c:catAx>
      <c:valAx>
        <c:axId val="5770601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105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accessions</a:t>
                </a:r>
                <a:endParaRPr lang="zh-CN" altLang="en-US" sz="105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04784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6FE0E9-D9E0-4D51-863E-4C3DA11833D8}" type="datetimeFigureOut">
              <a:rPr lang="zh-CN" altLang="en-US" smtClean="0"/>
              <a:pPr/>
              <a:t>2021/5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E81EBD-EEEE-4E7C-8B41-DAC3990325F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6E81EBD-EEEE-4E7C-8B41-DAC3990325F3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41265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6E81EBD-EEEE-4E7C-8B41-DAC3990325F3}" type="slidenum">
              <a:rPr lang="zh-CN" altLang="en-US" smtClean="0"/>
              <a:pPr/>
              <a:t>1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549185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6E81EBD-EEEE-4E7C-8B41-DAC3990325F3}" type="slidenum">
              <a:rPr lang="zh-CN" altLang="en-US" smtClean="0"/>
              <a:pPr/>
              <a:t>20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9306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0D67FB-F06A-4507-BF2E-FD0A9758B4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4B2E340-FE01-4305-A270-F9E15B7EBE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602D5CF-CBF7-4B21-87F5-F85E93A4CB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6200-CE6F-49A9-90C0-8868D5DDE17B}" type="datetimeFigureOut">
              <a:rPr lang="zh-CN" altLang="en-US" smtClean="0"/>
              <a:pPr/>
              <a:t>2021/5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00C63D-4F08-4D54-9E0D-3E234A187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F10A288-974F-406B-8B10-47F4B4590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9B9CB-6F51-491C-94CE-DF3E15AED85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21172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859734-424D-42ED-8671-9B444AEBBF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CB96314-608D-4B7E-8833-0B25996C63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86C103-949F-4CE3-8673-2028B815C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6200-CE6F-49A9-90C0-8868D5DDE17B}" type="datetimeFigureOut">
              <a:rPr lang="zh-CN" altLang="en-US" smtClean="0"/>
              <a:pPr/>
              <a:t>2021/5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3EC777-DB61-457D-8362-FE8E3363E9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3D4236-DCE2-4838-A4D7-694DA88A5B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9B9CB-6F51-491C-94CE-DF3E15AED85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0190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52C97D6-D33F-41F2-9C55-498629ACD4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F62DF5B-4E2C-4382-8712-77E8CF794A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2112F68-39A7-4808-8F62-C5782D445D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6200-CE6F-49A9-90C0-8868D5DDE17B}" type="datetimeFigureOut">
              <a:rPr lang="zh-CN" altLang="en-US" smtClean="0"/>
              <a:pPr/>
              <a:t>2021/5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901962-06A0-4FC2-99F5-8C7626B8BC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ECD8B51-630C-47CE-9BE1-FF796ED2D7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9B9CB-6F51-491C-94CE-DF3E15AED85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524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307E36-D35D-406A-B0F8-9B3C8B4C17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15F902D-30DB-4053-A985-24453CD58A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F3F7721-23AD-43A3-83FB-F51D3D43A1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6200-CE6F-49A9-90C0-8868D5DDE17B}" type="datetimeFigureOut">
              <a:rPr lang="zh-CN" altLang="en-US" smtClean="0"/>
              <a:pPr/>
              <a:t>2021/5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B332FFA-8A9C-45EB-8E65-A2B8CB99C6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C66FF3-4372-4A2B-B853-E4738960E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9B9CB-6F51-491C-94CE-DF3E15AED85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970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C687F0-65F0-4FDE-8172-9790453F3F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AD2A8AE-A9B5-4C4E-B3FB-0A338CFC36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43CEC64-5CF1-4E18-8985-BB8077993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6200-CE6F-49A9-90C0-8868D5DDE17B}" type="datetimeFigureOut">
              <a:rPr lang="zh-CN" altLang="en-US" smtClean="0"/>
              <a:pPr/>
              <a:t>2021/5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1714BB7-2DD8-4BFF-AB2C-8C8A7E2E9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319EB8-8D30-4056-8179-B8585BFBC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9B9CB-6F51-491C-94CE-DF3E15AED85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693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A5F7AB-F487-437D-B3E7-F1750E21B6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588DFAB-6320-4D18-BDE1-7272CBEBFE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5548602-B4A3-4B87-91A4-CFCC49CCA4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F92FA5C-530A-4B09-AFC1-248894135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6200-CE6F-49A9-90C0-8868D5DDE17B}" type="datetimeFigureOut">
              <a:rPr lang="zh-CN" altLang="en-US" smtClean="0"/>
              <a:pPr/>
              <a:t>2021/5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98B4D92-D82D-402C-995A-077FBAAD7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AF63B83-0803-4CEA-BA7C-438955ECE8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9B9CB-6F51-491C-94CE-DF3E15AED85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6358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7FC151-D8B7-40EA-A7D5-58F791A1C1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58B38DC-56AD-4C78-9E27-24632A6BAE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B52A471-27AD-43F1-A7FC-D0A413048C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07BA5B1-59C4-4EC1-BE63-6BDC727D52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0DE2DE6-CA71-4D58-994A-6094859E2B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68EC06F-6FBA-4417-8EAC-3A40DBF31C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6200-CE6F-49A9-90C0-8868D5DDE17B}" type="datetimeFigureOut">
              <a:rPr lang="zh-CN" altLang="en-US" smtClean="0"/>
              <a:pPr/>
              <a:t>2021/5/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8062027-7A45-4538-91B1-8ACD709530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852FE22-DC0E-4665-8A7E-7B0855F11A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9B9CB-6F51-491C-94CE-DF3E15AED85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3946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786DA4-EAF8-4A42-A347-21D8B0D5C8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A8C4B8B-91FB-4559-8841-F09BAD893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6200-CE6F-49A9-90C0-8868D5DDE17B}" type="datetimeFigureOut">
              <a:rPr lang="zh-CN" altLang="en-US" smtClean="0"/>
              <a:pPr/>
              <a:t>2021/5/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1F16ED1-74DC-4AE2-983F-FAB4B011B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E9CDE47-9F87-477C-B3A7-9BEADCF65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9B9CB-6F51-491C-94CE-DF3E15AED85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0214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381C172-B7DE-4ACA-A782-DD0136BFC7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6200-CE6F-49A9-90C0-8868D5DDE17B}" type="datetimeFigureOut">
              <a:rPr lang="zh-CN" altLang="en-US" smtClean="0"/>
              <a:pPr/>
              <a:t>2021/5/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18B7D78-E196-43A8-9590-0E2D333DFE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A463CB2-A396-4458-AB81-65E95C688B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9B9CB-6F51-491C-94CE-DF3E15AED85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4485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61161A-93A7-4045-9A34-DC73433DB0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A46047F-3830-4560-A7AB-BC3EBD3EA9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D34000C-9F64-4D24-9726-8E538101D3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F5582D6-B67E-4F97-A8EA-C8708B997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6200-CE6F-49A9-90C0-8868D5DDE17B}" type="datetimeFigureOut">
              <a:rPr lang="zh-CN" altLang="en-US" smtClean="0"/>
              <a:pPr/>
              <a:t>2021/5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485D36C-DF73-4D1C-AF6D-453258C379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981F3E9-44B5-4D9A-9904-1FBB62704F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9B9CB-6F51-491C-94CE-DF3E15AED85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2245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882A59-AEA3-45B8-9B21-EA98FBC7A1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9AC0E35-11D0-4410-AA63-D9DA0CC81E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246B626-0E26-4C9B-BE2B-812747EE37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ABD80DF-44D6-4F60-B2E3-B1D72B558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66200-CE6F-49A9-90C0-8868D5DDE17B}" type="datetimeFigureOut">
              <a:rPr lang="zh-CN" altLang="en-US" smtClean="0"/>
              <a:pPr/>
              <a:t>2021/5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7BA0BFF-B1AA-424B-9123-D723E3046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D45188E-DB72-438A-AB74-C17BD25B3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9B9CB-6F51-491C-94CE-DF3E15AED85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2888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1D545BB-DA95-4A1F-93AB-E4A8C91853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7EFDEFC-54DA-440E-B72F-B2A9EB1705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0009079-7F8B-4C0C-8349-F2BE0D4D33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66200-CE6F-49A9-90C0-8868D5DDE17B}" type="datetimeFigureOut">
              <a:rPr lang="zh-CN" altLang="en-US" smtClean="0"/>
              <a:pPr/>
              <a:t>2021/5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E4BCBC0-F23F-4541-A43C-DDA9EA4745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78B355D-F806-4A43-A698-E4A1931E46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F9B9CB-6F51-491C-94CE-DF3E15AED85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4629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6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9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4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7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 Box 3">
            <a:extLst>
              <a:ext uri="{FF2B5EF4-FFF2-40B4-BE49-F238E27FC236}">
                <a16:creationId xmlns:a16="http://schemas.microsoft.com/office/drawing/2014/main" id="{EF3C05C2-6D10-4B44-815C-9AB859A2D8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369" y="2290554"/>
            <a:ext cx="4306282" cy="410769"/>
          </a:xfrm>
          <a:prstGeom prst="rect">
            <a:avLst/>
          </a:prstGeom>
          <a:solidFill>
            <a:srgbClr val="FFAF00"/>
          </a:solidFill>
          <a:ln w="9525">
            <a:noFill/>
            <a:miter lim="800000"/>
            <a:headEnd/>
            <a:tailEnd/>
          </a:ln>
        </p:spPr>
        <p:txBody>
          <a:bodyPr lIns="18000" tIns="28800" rIns="18000" bIns="10800" anchor="ctr"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zh-CN" sz="2000" b="1" dirty="0">
                <a:solidFill>
                  <a:srgbClr val="40404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White jute (</a:t>
            </a:r>
            <a:r>
              <a:rPr lang="en-US" altLang="zh-CN" sz="2000" b="1" i="1" dirty="0">
                <a:solidFill>
                  <a:srgbClr val="40404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rchorus capsularis</a:t>
            </a:r>
            <a:r>
              <a:rPr lang="en-US" altLang="zh-CN" sz="2000" b="1" dirty="0">
                <a:solidFill>
                  <a:srgbClr val="40404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2" name="Text Box 3">
            <a:extLst>
              <a:ext uri="{FF2B5EF4-FFF2-40B4-BE49-F238E27FC236}">
                <a16:creationId xmlns:a16="http://schemas.microsoft.com/office/drawing/2014/main" id="{C1493B40-363A-4A66-8E5C-4D27661458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8632" y="4909314"/>
            <a:ext cx="4298057" cy="360040"/>
          </a:xfrm>
          <a:prstGeom prst="rect">
            <a:avLst/>
          </a:prstGeom>
          <a:solidFill>
            <a:srgbClr val="FFAF00"/>
          </a:solidFill>
          <a:ln w="9525">
            <a:noFill/>
            <a:miter lim="800000"/>
            <a:headEnd/>
            <a:tailEnd/>
          </a:ln>
        </p:spPr>
        <p:txBody>
          <a:bodyPr lIns="18000" tIns="28800" rIns="18000" bIns="10800" anchor="ctr"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zh-CN" sz="2000" b="1" dirty="0">
                <a:solidFill>
                  <a:srgbClr val="40404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Dark jute (</a:t>
            </a:r>
            <a:r>
              <a:rPr lang="en-US" altLang="zh-CN" sz="2000" b="1" i="1" dirty="0">
                <a:solidFill>
                  <a:srgbClr val="40404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. olitorius</a:t>
            </a:r>
            <a:r>
              <a:rPr lang="en-US" altLang="zh-CN" sz="2000" b="1" dirty="0">
                <a:solidFill>
                  <a:srgbClr val="404040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248006B-A075-44E0-8E72-3937E9079984}"/>
              </a:ext>
            </a:extLst>
          </p:cNvPr>
          <p:cNvSpPr txBox="1"/>
          <p:nvPr/>
        </p:nvSpPr>
        <p:spPr>
          <a:xfrm>
            <a:off x="5065692" y="1077292"/>
            <a:ext cx="689008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atures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pulari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r. ‘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uangm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79’ (HM179) and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olitoriu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r. ‘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uanyechangguo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(KYCG).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Pod shape and size: a</a:t>
            </a:r>
            <a:r>
              <a:rPr lang="en-US" altLang="zh-C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capsule shape pod in HM179; a</a:t>
            </a:r>
            <a:r>
              <a:rPr lang="en-US" altLang="zh-C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elongated pod in KYCG. 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Seed shape and color: b</a:t>
            </a:r>
            <a:r>
              <a:rPr lang="en-US" altLang="zh-C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chocolate brown seeds in HM179; b</a:t>
            </a:r>
            <a:r>
              <a:rPr lang="en-US" altLang="zh-CN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bluish green seeds in KYCG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B0D9A4E-40C6-4432-88EB-D31AEF545B29}"/>
              </a:ext>
            </a:extLst>
          </p:cNvPr>
          <p:cNvSpPr txBox="1"/>
          <p:nvPr/>
        </p:nvSpPr>
        <p:spPr>
          <a:xfrm>
            <a:off x="344369" y="349267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062E029-64C2-4908-AD69-FECAD82FEB3F}"/>
              </a:ext>
            </a:extLst>
          </p:cNvPr>
          <p:cNvSpPr txBox="1"/>
          <p:nvPr/>
        </p:nvSpPr>
        <p:spPr>
          <a:xfrm>
            <a:off x="344369" y="2836138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9752F085-3069-491A-A043-FFEBF960F09C}"/>
              </a:ext>
            </a:extLst>
          </p:cNvPr>
          <p:cNvSpPr txBox="1"/>
          <p:nvPr/>
        </p:nvSpPr>
        <p:spPr>
          <a:xfrm>
            <a:off x="2254166" y="289689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05C7145-5C04-45F4-B98E-8295497D6556}"/>
              </a:ext>
            </a:extLst>
          </p:cNvPr>
          <p:cNvSpPr txBox="1"/>
          <p:nvPr/>
        </p:nvSpPr>
        <p:spPr>
          <a:xfrm>
            <a:off x="2254166" y="388405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5CD0CECB-7496-4BC8-9EF2-FD22BC29B244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627120" y="779129"/>
            <a:ext cx="1649095" cy="123698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765467E7-7C80-40F1-A5F6-6B655C4E582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08304" y="3166663"/>
            <a:ext cx="1691787" cy="166892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7F6670E-DB95-4E91-B468-1CE302589F1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7760" y="3081556"/>
            <a:ext cx="1367814" cy="176815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100E6E0-2126-419B-8FD9-766495C631B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82966" y="598795"/>
            <a:ext cx="1664373" cy="1618033"/>
          </a:xfrm>
          <a:prstGeom prst="rect">
            <a:avLst/>
          </a:prstGeom>
        </p:spPr>
      </p:pic>
      <p:grpSp>
        <p:nvGrpSpPr>
          <p:cNvPr id="20" name="组合 19"/>
          <p:cNvGrpSpPr/>
          <p:nvPr/>
        </p:nvGrpSpPr>
        <p:grpSpPr>
          <a:xfrm>
            <a:off x="2788511" y="2021946"/>
            <a:ext cx="325529" cy="108000"/>
            <a:chOff x="6614160" y="4220160"/>
            <a:chExt cx="1097280" cy="108000"/>
          </a:xfrm>
        </p:grpSpPr>
        <p:cxnSp>
          <p:nvCxnSpPr>
            <p:cNvPr id="6" name="直接连接符 5"/>
            <p:cNvCxnSpPr/>
            <p:nvPr/>
          </p:nvCxnSpPr>
          <p:spPr>
            <a:xfrm>
              <a:off x="6614160" y="4328160"/>
              <a:ext cx="109728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连接符 16"/>
            <p:cNvCxnSpPr/>
            <p:nvPr/>
          </p:nvCxnSpPr>
          <p:spPr>
            <a:xfrm rot="5400000">
              <a:off x="6560160" y="4274160"/>
              <a:ext cx="108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连接符 21"/>
            <p:cNvCxnSpPr/>
            <p:nvPr/>
          </p:nvCxnSpPr>
          <p:spPr>
            <a:xfrm rot="5400000">
              <a:off x="7657440" y="4274160"/>
              <a:ext cx="108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文本框 20"/>
          <p:cNvSpPr txBox="1"/>
          <p:nvPr/>
        </p:nvSpPr>
        <p:spPr>
          <a:xfrm>
            <a:off x="2702560" y="1711721"/>
            <a:ext cx="8229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cm</a:t>
            </a:r>
            <a:endParaRPr lang="zh-CN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2" name="组合 31"/>
          <p:cNvGrpSpPr/>
          <p:nvPr/>
        </p:nvGrpSpPr>
        <p:grpSpPr>
          <a:xfrm>
            <a:off x="2820057" y="4619367"/>
            <a:ext cx="445029" cy="108016"/>
            <a:chOff x="6614160" y="4288729"/>
            <a:chExt cx="1097280" cy="59143"/>
          </a:xfrm>
        </p:grpSpPr>
        <p:cxnSp>
          <p:nvCxnSpPr>
            <p:cNvPr id="33" name="直接连接符 32"/>
            <p:cNvCxnSpPr/>
            <p:nvPr/>
          </p:nvCxnSpPr>
          <p:spPr>
            <a:xfrm>
              <a:off x="6614160" y="4347872"/>
              <a:ext cx="109728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33"/>
            <p:cNvCxnSpPr/>
            <p:nvPr/>
          </p:nvCxnSpPr>
          <p:spPr>
            <a:xfrm rot="5400000">
              <a:off x="6584594" y="4318297"/>
              <a:ext cx="59135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连接符 34"/>
            <p:cNvCxnSpPr/>
            <p:nvPr/>
          </p:nvCxnSpPr>
          <p:spPr>
            <a:xfrm rot="5400000">
              <a:off x="7681872" y="4318304"/>
              <a:ext cx="59134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文本框 35"/>
          <p:cNvSpPr txBox="1"/>
          <p:nvPr/>
        </p:nvSpPr>
        <p:spPr>
          <a:xfrm>
            <a:off x="2788511" y="4302568"/>
            <a:ext cx="8229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cm</a:t>
            </a:r>
            <a:endParaRPr lang="zh-CN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" name="组合 22"/>
          <p:cNvGrpSpPr/>
          <p:nvPr/>
        </p:nvGrpSpPr>
        <p:grpSpPr>
          <a:xfrm>
            <a:off x="1643217" y="2027151"/>
            <a:ext cx="360000" cy="109513"/>
            <a:chOff x="1643217" y="2027151"/>
            <a:chExt cx="360000" cy="109513"/>
          </a:xfrm>
        </p:grpSpPr>
        <p:cxnSp>
          <p:nvCxnSpPr>
            <p:cNvPr id="38" name="直接连接符 37"/>
            <p:cNvCxnSpPr/>
            <p:nvPr/>
          </p:nvCxnSpPr>
          <p:spPr>
            <a:xfrm>
              <a:off x="1643217" y="2136664"/>
              <a:ext cx="360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38"/>
            <p:cNvCxnSpPr/>
            <p:nvPr/>
          </p:nvCxnSpPr>
          <p:spPr>
            <a:xfrm rot="5400000">
              <a:off x="1589218" y="2082664"/>
              <a:ext cx="108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接连接符 39"/>
            <p:cNvCxnSpPr/>
            <p:nvPr/>
          </p:nvCxnSpPr>
          <p:spPr>
            <a:xfrm rot="5400000">
              <a:off x="1949216" y="2081151"/>
              <a:ext cx="108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文本框 40"/>
          <p:cNvSpPr txBox="1"/>
          <p:nvPr/>
        </p:nvSpPr>
        <p:spPr>
          <a:xfrm>
            <a:off x="1572726" y="1727486"/>
            <a:ext cx="8229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cm</a:t>
            </a:r>
            <a:endParaRPr lang="zh-CN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2" name="组合 41"/>
          <p:cNvGrpSpPr/>
          <p:nvPr/>
        </p:nvGrpSpPr>
        <p:grpSpPr>
          <a:xfrm>
            <a:off x="1680843" y="4622155"/>
            <a:ext cx="388912" cy="108000"/>
            <a:chOff x="6614160" y="4220160"/>
            <a:chExt cx="1097280" cy="108000"/>
          </a:xfrm>
        </p:grpSpPr>
        <p:cxnSp>
          <p:nvCxnSpPr>
            <p:cNvPr id="43" name="直接连接符 42"/>
            <p:cNvCxnSpPr/>
            <p:nvPr/>
          </p:nvCxnSpPr>
          <p:spPr>
            <a:xfrm>
              <a:off x="6614160" y="4328160"/>
              <a:ext cx="109728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连接符 43"/>
            <p:cNvCxnSpPr/>
            <p:nvPr/>
          </p:nvCxnSpPr>
          <p:spPr>
            <a:xfrm rot="5400000">
              <a:off x="6560160" y="4274160"/>
              <a:ext cx="108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/>
            <p:cNvCxnSpPr/>
            <p:nvPr/>
          </p:nvCxnSpPr>
          <p:spPr>
            <a:xfrm rot="5400000">
              <a:off x="7657440" y="4274160"/>
              <a:ext cx="108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" name="文本框 45"/>
          <p:cNvSpPr txBox="1"/>
          <p:nvPr/>
        </p:nvSpPr>
        <p:spPr>
          <a:xfrm>
            <a:off x="1594892" y="4314377"/>
            <a:ext cx="8229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cm</a:t>
            </a:r>
            <a:endParaRPr lang="zh-CN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09003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>
            <a:extLst>
              <a:ext uri="{FF2B5EF4-FFF2-40B4-BE49-F238E27FC236}">
                <a16:creationId xmlns:a16="http://schemas.microsoft.com/office/drawing/2014/main" id="{0F81B09A-F842-41CD-BF0D-5F8C12D658BE}"/>
              </a:ext>
            </a:extLst>
          </p:cNvPr>
          <p:cNvGrpSpPr/>
          <p:nvPr/>
        </p:nvGrpSpPr>
        <p:grpSpPr>
          <a:xfrm>
            <a:off x="953872" y="203930"/>
            <a:ext cx="4900964" cy="2435599"/>
            <a:chOff x="0" y="0"/>
            <a:chExt cx="2820247" cy="1210521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CA80F627-1ACB-4159-ADAD-DF85860A7F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16" t="47432" b="46825"/>
            <a:stretch/>
          </p:blipFill>
          <p:spPr>
            <a:xfrm>
              <a:off x="97367" y="237066"/>
              <a:ext cx="2722880" cy="973455"/>
            </a:xfrm>
            <a:prstGeom prst="rect">
              <a:avLst/>
            </a:prstGeom>
          </p:spPr>
        </p:pic>
        <p:sp>
          <p:nvSpPr>
            <p:cNvPr id="9" name="文本框 96">
              <a:extLst>
                <a:ext uri="{FF2B5EF4-FFF2-40B4-BE49-F238E27FC236}">
                  <a16:creationId xmlns:a16="http://schemas.microsoft.com/office/drawing/2014/main" id="{B5F0A2D9-78A6-462A-AB49-4224BC3CB7E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0" y="0"/>
              <a:ext cx="271780" cy="3060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algn="just"/>
              <a:r>
                <a:rPr lang="en-US" altLang="zh-CN" sz="1200" kern="100" dirty="0"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</a:t>
              </a:r>
              <a:endParaRPr lang="zh-CN" sz="105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124C0987-E61F-44BF-A4DB-548332C979C4}"/>
              </a:ext>
            </a:extLst>
          </p:cNvPr>
          <p:cNvGrpSpPr/>
          <p:nvPr/>
        </p:nvGrpSpPr>
        <p:grpSpPr>
          <a:xfrm>
            <a:off x="943404" y="2639529"/>
            <a:ext cx="4911432" cy="2198895"/>
            <a:chOff x="0" y="0"/>
            <a:chExt cx="2759710" cy="1147445"/>
          </a:xfrm>
        </p:grpSpPr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76CE78CF-A183-4DCF-896A-282BF32FA4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9" t="22596" b="68701"/>
            <a:stretch/>
          </p:blipFill>
          <p:spPr>
            <a:xfrm>
              <a:off x="135890" y="153035"/>
              <a:ext cx="2623820" cy="994410"/>
            </a:xfrm>
            <a:prstGeom prst="rect">
              <a:avLst/>
            </a:prstGeom>
          </p:spPr>
        </p:pic>
        <p:sp>
          <p:nvSpPr>
            <p:cNvPr id="16" name="文本框 97">
              <a:extLst>
                <a:ext uri="{FF2B5EF4-FFF2-40B4-BE49-F238E27FC236}">
                  <a16:creationId xmlns:a16="http://schemas.microsoft.com/office/drawing/2014/main" id="{E6AE25C6-7717-4255-842E-83EB167AF7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0" y="0"/>
              <a:ext cx="271780" cy="3060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algn="just"/>
              <a:r>
                <a:rPr lang="en-US" sz="1200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b</a:t>
              </a:r>
              <a:endParaRPr lang="zh-CN" sz="105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19" name="文本框 18">
            <a:extLst>
              <a:ext uri="{FF2B5EF4-FFF2-40B4-BE49-F238E27FC236}">
                <a16:creationId xmlns:a16="http://schemas.microsoft.com/office/drawing/2014/main" id="{1C849C7A-EAD5-4D8E-8EA9-8DC33CEDEAC9}"/>
              </a:ext>
            </a:extLst>
          </p:cNvPr>
          <p:cNvSpPr txBox="1"/>
          <p:nvPr/>
        </p:nvSpPr>
        <p:spPr>
          <a:xfrm>
            <a:off x="6034506" y="1190222"/>
            <a:ext cx="6002163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 structure and admixture analysis among 299 accessions in jute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Population admixture showing K=13 among 242 accessions withi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capsularis.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Population admixture showing K=3 among 57 accessions withi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olitorius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507055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Users\llzhang\Desktop\JuteGenome\JuteGenomeFromXiaokai\migration events\group.mm100.maf5.mg0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4516" y="1679417"/>
            <a:ext cx="4572000" cy="4572000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2180878" y="6031582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09118" y="298597"/>
            <a:ext cx="1127968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1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ene flow in jute natural population after their divergence.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Migration events showed that there was no gene flow betwee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capsulari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olitoriu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their divergence. 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Partial gene flow has occurred withi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capsularis.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204424" y="6031582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pic>
        <p:nvPicPr>
          <p:cNvPr id="9" name="Picture 3" descr="C:\Users\llzhang\Desktop\JuteGenome\JuteGenomeFromXiaokai\migration events\group.mm100.maf5.mg0.rsd.png">
            <a:extLst>
              <a:ext uri="{FF2B5EF4-FFF2-40B4-BE49-F238E27FC236}">
                <a16:creationId xmlns:a16="http://schemas.microsoft.com/office/drawing/2014/main" id="{5C1F32FF-45B1-4267-A108-79BBD1552C4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918424" y="1644248"/>
            <a:ext cx="4572000" cy="4572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>
            <a:extLst>
              <a:ext uri="{FF2B5EF4-FFF2-40B4-BE49-F238E27FC236}">
                <a16:creationId xmlns:a16="http://schemas.microsoft.com/office/drawing/2014/main" id="{F6B30F5D-DF5C-409B-8B6C-708B88DB6375}"/>
              </a:ext>
            </a:extLst>
          </p:cNvPr>
          <p:cNvGrpSpPr/>
          <p:nvPr/>
        </p:nvGrpSpPr>
        <p:grpSpPr>
          <a:xfrm>
            <a:off x="124911" y="948403"/>
            <a:ext cx="11942177" cy="1893017"/>
            <a:chOff x="124911" y="1014187"/>
            <a:chExt cx="11942177" cy="1893017"/>
          </a:xfrm>
        </p:grpSpPr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E87A7DFE-D0CD-40D6-B49F-4A3C909FFC1A}"/>
                </a:ext>
              </a:extLst>
            </p:cNvPr>
            <p:cNvGrpSpPr/>
            <p:nvPr/>
          </p:nvGrpSpPr>
          <p:grpSpPr>
            <a:xfrm>
              <a:off x="124911" y="1014187"/>
              <a:ext cx="11942177" cy="1893017"/>
              <a:chOff x="0" y="2902192"/>
              <a:chExt cx="11942177" cy="1893017"/>
            </a:xfrm>
          </p:grpSpPr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F68900AF-F3E1-4A8D-AD03-6DE2A343759E}"/>
                  </a:ext>
                </a:extLst>
              </p:cNvPr>
              <p:cNvSpPr txBox="1"/>
              <p:nvPr/>
            </p:nvSpPr>
            <p:spPr>
              <a:xfrm>
                <a:off x="5550690" y="3281628"/>
                <a:ext cx="81148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GM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22" name="图片 21">
                <a:extLst>
                  <a:ext uri="{FF2B5EF4-FFF2-40B4-BE49-F238E27FC236}">
                    <a16:creationId xmlns:a16="http://schemas.microsoft.com/office/drawing/2014/main" id="{AED9DD7B-0D76-4236-8B68-9618311B2C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62177" y="2935209"/>
                <a:ext cx="5580000" cy="1860000"/>
              </a:xfrm>
              <a:prstGeom prst="rect">
                <a:avLst/>
              </a:prstGeom>
            </p:spPr>
          </p:pic>
          <p:pic>
            <p:nvPicPr>
              <p:cNvPr id="24" name="图片 23">
                <a:extLst>
                  <a:ext uri="{FF2B5EF4-FFF2-40B4-BE49-F238E27FC236}">
                    <a16:creationId xmlns:a16="http://schemas.microsoft.com/office/drawing/2014/main" id="{01DA1870-5A6A-43E3-9F03-2F23EA1CAB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2902192"/>
                <a:ext cx="5580000" cy="1860000"/>
              </a:xfrm>
              <a:prstGeom prst="rect">
                <a:avLst/>
              </a:prstGeom>
            </p:spPr>
          </p:pic>
        </p:grpSp>
        <p:sp>
          <p:nvSpPr>
            <p:cNvPr id="3" name="矩形 2">
              <a:extLst>
                <a:ext uri="{FF2B5EF4-FFF2-40B4-BE49-F238E27FC236}">
                  <a16:creationId xmlns:a16="http://schemas.microsoft.com/office/drawing/2014/main" id="{9319F4CF-CC89-4D29-B7D5-AA4CE21CCCA3}"/>
                </a:ext>
              </a:extLst>
            </p:cNvPr>
            <p:cNvSpPr/>
            <p:nvPr/>
          </p:nvSpPr>
          <p:spPr>
            <a:xfrm>
              <a:off x="1998734" y="1014187"/>
              <a:ext cx="100540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/>
              <a:r>
                <a:rPr lang="en-US" sz="1200" i="1" kern="1200" dirty="0">
                  <a:solidFill>
                    <a:srgbClr val="FFFFFF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. capsularis</a:t>
              </a:r>
              <a:endParaRPr lang="zh-CN" sz="20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47CF21D6-A221-4026-875B-C87B86491C9A}"/>
                </a:ext>
              </a:extLst>
            </p:cNvPr>
            <p:cNvSpPr/>
            <p:nvPr/>
          </p:nvSpPr>
          <p:spPr>
            <a:xfrm>
              <a:off x="8779737" y="1083105"/>
              <a:ext cx="88678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/>
              <a:r>
                <a:rPr lang="en-US" sz="1200" i="1" kern="1200" dirty="0">
                  <a:solidFill>
                    <a:srgbClr val="FFFFFF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. olitorius</a:t>
              </a:r>
              <a:endParaRPr lang="zh-CN" sz="20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DDA35F4E-390C-412F-853F-D1EB04FB5640}"/>
                </a:ext>
              </a:extLst>
            </p:cNvPr>
            <p:cNvPicPr/>
            <p:nvPr/>
          </p:nvPicPr>
          <p:blipFill rotWithShape="1">
            <a:blip r:embed="rId4" cstate="print"/>
            <a:srcRect l="70519" t="4901" r="9422" b="76136"/>
            <a:stretch/>
          </p:blipFill>
          <p:spPr>
            <a:xfrm>
              <a:off x="5064439" y="1035369"/>
              <a:ext cx="552649" cy="683741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F4817C6A-56C6-4525-9B9E-74996984DF08}"/>
                </a:ext>
              </a:extLst>
            </p:cNvPr>
            <p:cNvPicPr/>
            <p:nvPr/>
          </p:nvPicPr>
          <p:blipFill rotWithShape="1">
            <a:blip r:embed="rId5" cstate="print"/>
            <a:srcRect l="70519" t="50994" r="9422" b="32451"/>
            <a:stretch/>
          </p:blipFill>
          <p:spPr>
            <a:xfrm>
              <a:off x="11570179" y="1037826"/>
              <a:ext cx="496909" cy="644556"/>
            </a:xfrm>
            <a:prstGeom prst="rect">
              <a:avLst/>
            </a:prstGeom>
          </p:spPr>
        </p:pic>
      </p:grpSp>
      <p:sp>
        <p:nvSpPr>
          <p:cNvPr id="34" name="文本框 33">
            <a:extLst>
              <a:ext uri="{FF2B5EF4-FFF2-40B4-BE49-F238E27FC236}">
                <a16:creationId xmlns:a16="http://schemas.microsoft.com/office/drawing/2014/main" id="{BE3322AE-B00E-4A60-860D-3C979FF2BC95}"/>
              </a:ext>
            </a:extLst>
          </p:cNvPr>
          <p:cNvSpPr txBox="1"/>
          <p:nvPr/>
        </p:nvSpPr>
        <p:spPr>
          <a:xfrm>
            <a:off x="609325" y="3187839"/>
            <a:ext cx="1051587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2</a:t>
            </a:r>
            <a:endParaRPr lang="en-US" altLang="zh-CN" sz="1800" dirty="0">
              <a:effectLst/>
              <a:latin typeface="Times New Roman" panose="02020603050405020304" pitchFamily="18" charset="0"/>
              <a:ea typeface="等线" panose="02010600030101010101" pitchFamily="2" charset="-122"/>
            </a:endParaRPr>
          </a:p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he predicted distribution map of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C. capsularis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nd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C. olitorius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inferred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using their longitude and latitude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ositions in Last Glacial Maximum (LGM)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1137998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>
            <a:extLst>
              <a:ext uri="{FF2B5EF4-FFF2-40B4-BE49-F238E27FC236}">
                <a16:creationId xmlns:a16="http://schemas.microsoft.com/office/drawing/2014/main" id="{977C3599-3888-4844-9C59-D333B3CA9F99}"/>
              </a:ext>
            </a:extLst>
          </p:cNvPr>
          <p:cNvGrpSpPr/>
          <p:nvPr/>
        </p:nvGrpSpPr>
        <p:grpSpPr>
          <a:xfrm>
            <a:off x="121763" y="926675"/>
            <a:ext cx="11948473" cy="1870834"/>
            <a:chOff x="0" y="926675"/>
            <a:chExt cx="11948473" cy="1870834"/>
          </a:xfrm>
        </p:grpSpPr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30C7BD55-39F2-4944-A2E3-C00F4EEBD033}"/>
                </a:ext>
              </a:extLst>
            </p:cNvPr>
            <p:cNvSpPr/>
            <p:nvPr/>
          </p:nvSpPr>
          <p:spPr>
            <a:xfrm>
              <a:off x="5510964" y="1534810"/>
              <a:ext cx="93326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d-</a:t>
              </a:r>
              <a:r>
                <a:rPr lang="en-US" altLang="zh-CN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olocene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2E0BB604-C6ED-47E1-A752-1EAF6C5168FB}"/>
                </a:ext>
              </a:extLst>
            </p:cNvPr>
            <p:cNvGrpSpPr/>
            <p:nvPr/>
          </p:nvGrpSpPr>
          <p:grpSpPr>
            <a:xfrm>
              <a:off x="0" y="926675"/>
              <a:ext cx="11948473" cy="1870834"/>
              <a:chOff x="0" y="926675"/>
              <a:chExt cx="11948473" cy="1870834"/>
            </a:xfrm>
          </p:grpSpPr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BA502EF8-A55B-4477-99F2-4F61194A19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926675"/>
                <a:ext cx="5580000" cy="1860000"/>
              </a:xfrm>
              <a:prstGeom prst="rect">
                <a:avLst/>
              </a:prstGeom>
            </p:spPr>
          </p:pic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id="{44CE464D-FFBF-4EE8-AEC3-07CBB7C2EA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68473" y="937509"/>
                <a:ext cx="5580000" cy="1860000"/>
              </a:xfrm>
              <a:prstGeom prst="rect">
                <a:avLst/>
              </a:prstGeom>
            </p:spPr>
          </p:pic>
          <p:sp>
            <p:nvSpPr>
              <p:cNvPr id="2" name="矩形 1">
                <a:extLst>
                  <a:ext uri="{FF2B5EF4-FFF2-40B4-BE49-F238E27FC236}">
                    <a16:creationId xmlns:a16="http://schemas.microsoft.com/office/drawing/2014/main" id="{CA7F21A6-4CFE-42BF-B135-F915CD2D4D9A}"/>
                  </a:ext>
                </a:extLst>
              </p:cNvPr>
              <p:cNvSpPr/>
              <p:nvPr/>
            </p:nvSpPr>
            <p:spPr>
              <a:xfrm>
                <a:off x="1998734" y="948403"/>
                <a:ext cx="100540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200" i="1" kern="1200" dirty="0">
                    <a:solidFill>
                      <a:srgbClr val="FFFFFF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C. capsularis</a:t>
                </a:r>
                <a:endParaRPr lang="zh-CN" sz="2000" kern="100" dirty="0">
                  <a:effectLst/>
                  <a:latin typeface="等线" panose="02010600030101010101" pitchFamily="2" charset="-122"/>
                  <a:ea typeface="等线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" name="矩形 2">
                <a:extLst>
                  <a:ext uri="{FF2B5EF4-FFF2-40B4-BE49-F238E27FC236}">
                    <a16:creationId xmlns:a16="http://schemas.microsoft.com/office/drawing/2014/main" id="{963A9B10-0F00-4A26-9D54-4BD32C1E3EF9}"/>
                  </a:ext>
                </a:extLst>
              </p:cNvPr>
              <p:cNvSpPr/>
              <p:nvPr/>
            </p:nvSpPr>
            <p:spPr>
              <a:xfrm>
                <a:off x="8715082" y="997586"/>
                <a:ext cx="88678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just"/>
                <a:r>
                  <a:rPr lang="en-US" sz="1200" i="1" kern="1200" dirty="0">
                    <a:solidFill>
                      <a:srgbClr val="FFFFFF"/>
                    </a:solidFill>
                    <a:effectLst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C. olitorius</a:t>
                </a:r>
                <a:endParaRPr lang="zh-CN" sz="2000" kern="100" dirty="0">
                  <a:effectLst/>
                  <a:latin typeface="等线" panose="02010600030101010101" pitchFamily="2" charset="-122"/>
                  <a:ea typeface="等线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91875109-445B-4F49-B0EF-96F8BCBEFCDE}"/>
                  </a:ext>
                </a:extLst>
              </p:cNvPr>
              <p:cNvPicPr/>
              <p:nvPr/>
            </p:nvPicPr>
            <p:blipFill rotWithShape="1">
              <a:blip r:embed="rId4" cstate="print"/>
              <a:srcRect l="70519" t="4901" r="9422" b="76136"/>
              <a:stretch/>
            </p:blipFill>
            <p:spPr>
              <a:xfrm>
                <a:off x="5002871" y="961320"/>
                <a:ext cx="552649" cy="683741"/>
              </a:xfrm>
              <a:prstGeom prst="rect">
                <a:avLst/>
              </a:prstGeom>
            </p:spPr>
          </p:pic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1B300139-6CF6-4FF6-9BB9-7A1C8A78CF9E}"/>
                  </a:ext>
                </a:extLst>
              </p:cNvPr>
              <p:cNvPicPr/>
              <p:nvPr/>
            </p:nvPicPr>
            <p:blipFill rotWithShape="1">
              <a:blip r:embed="rId5" cstate="print"/>
              <a:srcRect l="70519" t="50994" r="9422" b="32451"/>
              <a:stretch/>
            </p:blipFill>
            <p:spPr>
              <a:xfrm>
                <a:off x="11442107" y="952307"/>
                <a:ext cx="496909" cy="644556"/>
              </a:xfrm>
              <a:prstGeom prst="rect">
                <a:avLst/>
              </a:prstGeom>
            </p:spPr>
          </p:pic>
        </p:grpSp>
      </p:grpSp>
      <p:sp>
        <p:nvSpPr>
          <p:cNvPr id="31" name="文本框 30">
            <a:extLst>
              <a:ext uri="{FF2B5EF4-FFF2-40B4-BE49-F238E27FC236}">
                <a16:creationId xmlns:a16="http://schemas.microsoft.com/office/drawing/2014/main" id="{D900A1C1-9FF1-44A4-BF4B-AD9718672634}"/>
              </a:ext>
            </a:extLst>
          </p:cNvPr>
          <p:cNvSpPr txBox="1"/>
          <p:nvPr/>
        </p:nvSpPr>
        <p:spPr>
          <a:xfrm>
            <a:off x="1259744" y="3360165"/>
            <a:ext cx="940825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3</a:t>
            </a:r>
            <a:endParaRPr lang="en-US" altLang="zh-CN" sz="1800" dirty="0">
              <a:effectLst/>
              <a:latin typeface="Times New Roman" panose="02020603050405020304" pitchFamily="18" charset="0"/>
              <a:ea typeface="等线" panose="02010600030101010101" pitchFamily="2" charset="-122"/>
            </a:endParaRPr>
          </a:p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he predicted distribution map of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C. capsularis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nd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C. olitorius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inferred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using their longitude and latitude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ositions in mid-Holocene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9398063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ED3C2884-7FC4-4DC7-84DB-51CF94336B2A}"/>
              </a:ext>
            </a:extLst>
          </p:cNvPr>
          <p:cNvSpPr txBox="1"/>
          <p:nvPr/>
        </p:nvSpPr>
        <p:spPr>
          <a:xfrm>
            <a:off x="5295900" y="4086225"/>
            <a:ext cx="567689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4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 frequency distribution of cellulose content of bast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bre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299 jute accessions grown in three year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图表 6">
            <a:extLst>
              <a:ext uri="{FF2B5EF4-FFF2-40B4-BE49-F238E27FC236}">
                <a16:creationId xmlns:a16="http://schemas.microsoft.com/office/drawing/2014/main" id="{AE0266AF-D479-40AF-8BC6-5C65DF155BA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2071079"/>
              </p:ext>
            </p:extLst>
          </p:nvPr>
        </p:nvGraphicFramePr>
        <p:xfrm>
          <a:off x="545211" y="20955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图表 7">
            <a:extLst>
              <a:ext uri="{FF2B5EF4-FFF2-40B4-BE49-F238E27FC236}">
                <a16:creationId xmlns:a16="http://schemas.microsoft.com/office/drawing/2014/main" id="{AE086B88-3557-4AA1-9D48-1630386B82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6275254"/>
              </p:ext>
            </p:extLst>
          </p:nvPr>
        </p:nvGraphicFramePr>
        <p:xfrm>
          <a:off x="5035297" y="209550"/>
          <a:ext cx="481050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图表 8">
            <a:extLst>
              <a:ext uri="{FF2B5EF4-FFF2-40B4-BE49-F238E27FC236}">
                <a16:creationId xmlns:a16="http://schemas.microsoft.com/office/drawing/2014/main" id="{514795E8-086D-4330-A9D3-74E135E6CBF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1600669"/>
              </p:ext>
            </p:extLst>
          </p:nvPr>
        </p:nvGraphicFramePr>
        <p:xfrm>
          <a:off x="545211" y="3242310"/>
          <a:ext cx="4572000" cy="2667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53399668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493BD9C-49A3-44BC-9707-D2BFE429CD94}"/>
              </a:ext>
            </a:extLst>
          </p:cNvPr>
          <p:cNvSpPr txBox="1"/>
          <p:nvPr/>
        </p:nvSpPr>
        <p:spPr>
          <a:xfrm>
            <a:off x="6096000" y="4695825"/>
            <a:ext cx="558165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5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 frequency distribution of lignin content in 299 jute accessions grown in three year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图表 2">
            <a:extLst>
              <a:ext uri="{FF2B5EF4-FFF2-40B4-BE49-F238E27FC236}">
                <a16:creationId xmlns:a16="http://schemas.microsoft.com/office/drawing/2014/main" id="{00000000-0008-0000-04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3197637"/>
              </p:ext>
            </p:extLst>
          </p:nvPr>
        </p:nvGraphicFramePr>
        <p:xfrm>
          <a:off x="918055" y="693420"/>
          <a:ext cx="4800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图表 4">
            <a:extLst>
              <a:ext uri="{FF2B5EF4-FFF2-40B4-BE49-F238E27FC236}">
                <a16:creationId xmlns:a16="http://schemas.microsoft.com/office/drawing/2014/main" id="{00000000-0008-0000-04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0179010"/>
              </p:ext>
            </p:extLst>
          </p:nvPr>
        </p:nvGraphicFramePr>
        <p:xfrm>
          <a:off x="5551015" y="685800"/>
          <a:ext cx="463296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图表 5">
            <a:extLst>
              <a:ext uri="{FF2B5EF4-FFF2-40B4-BE49-F238E27FC236}">
                <a16:creationId xmlns:a16="http://schemas.microsoft.com/office/drawing/2014/main" id="{00000000-0008-0000-04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0487568"/>
              </p:ext>
            </p:extLst>
          </p:nvPr>
        </p:nvGraphicFramePr>
        <p:xfrm>
          <a:off x="918055" y="3931142"/>
          <a:ext cx="463296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55061135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5554D0E-2872-4773-B5BD-67100BD7586B}"/>
              </a:ext>
            </a:extLst>
          </p:cNvPr>
          <p:cNvSpPr txBox="1"/>
          <p:nvPr/>
        </p:nvSpPr>
        <p:spPr>
          <a:xfrm>
            <a:off x="5495924" y="4162425"/>
            <a:ext cx="570547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6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 frequency distribution of 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bre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neness in 299 jute accessions grown in three year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图表 5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4227755"/>
              </p:ext>
            </p:extLst>
          </p:nvPr>
        </p:nvGraphicFramePr>
        <p:xfrm>
          <a:off x="5331279" y="6858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图表 6">
            <a:extLst>
              <a:ext uri="{FF2B5EF4-FFF2-40B4-BE49-F238E27FC236}">
                <a16:creationId xmlns:a16="http://schemas.microsoft.com/office/drawing/2014/main" id="{00000000-0008-0000-03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3356261"/>
              </p:ext>
            </p:extLst>
          </p:nvPr>
        </p:nvGraphicFramePr>
        <p:xfrm>
          <a:off x="759279" y="69342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图表 7">
            <a:extLst>
              <a:ext uri="{FF2B5EF4-FFF2-40B4-BE49-F238E27FC236}">
                <a16:creationId xmlns:a16="http://schemas.microsoft.com/office/drawing/2014/main" id="{00000000-0008-0000-03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8953564"/>
              </p:ext>
            </p:extLst>
          </p:nvPr>
        </p:nvGraphicFramePr>
        <p:xfrm>
          <a:off x="759279" y="371415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54083039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7BD96CF-56D6-4B82-8A15-381D164342BB}"/>
              </a:ext>
            </a:extLst>
          </p:cNvPr>
          <p:cNvSpPr txBox="1"/>
          <p:nvPr/>
        </p:nvSpPr>
        <p:spPr>
          <a:xfrm>
            <a:off x="415636" y="0"/>
            <a:ext cx="11550695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7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-wide association studies of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br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neness in 299 jute accessions grown in different years.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Manhattan plots generated from genome-wide association analysis results for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br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neness traits in 2016. Negative log</a:t>
            </a:r>
            <a:r>
              <a:rPr lang="en-US" altLang="zh-CN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from a genome-wide scan are plotted against position on each of seven chromosomes. Dashed line represents the significance threshold. 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Quantile-quantile plot for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br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neness in 2016. 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Manhattan plots generated from genome-wide association analysis results for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br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neness traits in 2017. Negative log</a:t>
            </a:r>
            <a:r>
              <a:rPr lang="en-US" altLang="zh-CN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from a genome-wide scan are plotted against position on each of seven chromosomes. Dashed line represents the significance threshold. 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Quantile-quantile plot for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br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neness in 2017.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636" y="1815882"/>
            <a:ext cx="8349673" cy="2570134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54836" y="1815882"/>
            <a:ext cx="2570134" cy="2570134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636" y="4287866"/>
            <a:ext cx="8349673" cy="2570134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54836" y="4137340"/>
            <a:ext cx="2570134" cy="2570134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92318" y="2043606"/>
            <a:ext cx="4988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92317" y="4386016"/>
            <a:ext cx="4988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8769880" y="2043606"/>
            <a:ext cx="5116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8751410" y="4386016"/>
            <a:ext cx="5116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7054066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A312073A-1072-4302-B34B-38D40F9CA536}"/>
              </a:ext>
            </a:extLst>
          </p:cNvPr>
          <p:cNvSpPr txBox="1"/>
          <p:nvPr/>
        </p:nvSpPr>
        <p:spPr>
          <a:xfrm>
            <a:off x="197352" y="4870043"/>
            <a:ext cx="1173492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8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RNA-seq expression comparison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COBRA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one GWAS candidate gene, of stem barks at different development stage. Data are means ± SD calculated from three biological replicates (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1)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0BE006FD-BDE1-4815-BA6F-D7CB96406E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0045008"/>
              </p:ext>
            </p:extLst>
          </p:nvPr>
        </p:nvGraphicFramePr>
        <p:xfrm>
          <a:off x="4400317" y="489311"/>
          <a:ext cx="3568026" cy="44932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90382423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7E621283-034E-4349-B36E-56C51C62F7D6}"/>
              </a:ext>
            </a:extLst>
          </p:cNvPr>
          <p:cNvSpPr txBox="1"/>
          <p:nvPr/>
        </p:nvSpPr>
        <p:spPr>
          <a:xfrm>
            <a:off x="134815" y="-7568"/>
            <a:ext cx="11922369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9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-wide association studies of cellulose content in 299 jute accessions grown in different years.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Manhattan plots generated from genome-wide association analysis results for cellulose content traits in 2016. Negative log</a:t>
            </a:r>
            <a:r>
              <a:rPr lang="en-US" altLang="zh-CN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from a genome-wide scan are plotted against position on each of seven chromosomes. Dashed line represents the significance threshold. 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Quantile-quantile plot for cellulose content in 2016. 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Manhattan plots generated from genome-wide association analysis results for cellulose content traits in 2017. Negative log</a:t>
            </a:r>
            <a:r>
              <a:rPr lang="en-US" altLang="zh-CN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from a genome-wide scan are plotted against position on each of seven chromosomes. Dashed line represents the significance threshold. 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Quantile-quantile plot for cellulose content in 2017.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815" y="1870146"/>
            <a:ext cx="5015115" cy="249865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7509" y="1870146"/>
            <a:ext cx="2498655" cy="2498655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327387" y="1870146"/>
            <a:ext cx="477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5857224" y="1870146"/>
            <a:ext cx="477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dirty="0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815" y="4368801"/>
            <a:ext cx="4949388" cy="24892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7509" y="4368801"/>
            <a:ext cx="2467389" cy="2467389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326313" y="4368801"/>
            <a:ext cx="477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5854811" y="4368801"/>
            <a:ext cx="477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012316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1F17716-C565-4B16-868A-2B14AEEB47A6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880183"/>
            <a:ext cx="4540992" cy="454099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2FE355C-B27E-4D33-BBB1-F13646398848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0579" y="1923602"/>
            <a:ext cx="4497573" cy="4497573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1EFC04F1-0B11-4B9A-994D-F12C70296E3F}"/>
              </a:ext>
            </a:extLst>
          </p:cNvPr>
          <p:cNvSpPr txBox="1"/>
          <p:nvPr/>
        </p:nvSpPr>
        <p:spPr>
          <a:xfrm>
            <a:off x="2040103" y="917074"/>
            <a:ext cx="81117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timation of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 capsulari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and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. olitoriu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 size based on 19 K-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r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. </a:t>
            </a:r>
          </a:p>
        </p:txBody>
      </p:sp>
    </p:spTree>
    <p:extLst>
      <p:ext uri="{BB962C8B-B14F-4D97-AF65-F5344CB8AC3E}">
        <p14:creationId xmlns:p14="http://schemas.microsoft.com/office/powerpoint/2010/main" val="331371794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A312073A-1072-4302-B34B-38D40F9CA536}"/>
              </a:ext>
            </a:extLst>
          </p:cNvPr>
          <p:cNvSpPr txBox="1"/>
          <p:nvPr/>
        </p:nvSpPr>
        <p:spPr>
          <a:xfrm>
            <a:off x="197352" y="4870043"/>
            <a:ext cx="1173492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0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RNA-seq expression comparison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C4H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one GWAS candidate gene, of leaves and stem barks between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. capsularis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d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. olitoriu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the vigorous growth stage (60 days after sowing). Data are means ± SD calculated from three biological replicates (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1)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1FF10EE0-447A-4648-A7DF-D522430F792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5717819"/>
              </p:ext>
            </p:extLst>
          </p:nvPr>
        </p:nvGraphicFramePr>
        <p:xfrm>
          <a:off x="4016051" y="578498"/>
          <a:ext cx="4159898" cy="41662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78578409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7D9883FF-9F9F-4A07-8C62-1DA84785274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9766"/>
            <a:ext cx="3793923" cy="3451636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3A18E25-4B0D-4D33-A93A-1B218C9C418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0989" y="163796"/>
            <a:ext cx="3763721" cy="3451636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93368312-9116-48A5-B74A-E5383CF35B8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4710" y="167826"/>
            <a:ext cx="3883090" cy="3451636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03C95006-0735-4A9E-B498-6DFC09047060}"/>
              </a:ext>
            </a:extLst>
          </p:cNvPr>
          <p:cNvSpPr txBox="1"/>
          <p:nvPr/>
        </p:nvSpPr>
        <p:spPr>
          <a:xfrm>
            <a:off x="1035698" y="4460033"/>
            <a:ext cx="1039210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1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 pathway enrichment analysis for the candidate genes in the overlapped improvement and selection outliers detected between different geographical sources i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capsulari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D0477FF-83FC-40BC-84B7-88D64A761060}"/>
              </a:ext>
            </a:extLst>
          </p:cNvPr>
          <p:cNvSpPr txBox="1"/>
          <p:nvPr/>
        </p:nvSpPr>
        <p:spPr>
          <a:xfrm>
            <a:off x="1326562" y="3771168"/>
            <a:ext cx="10254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component                                        molecular function                                         biological proces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552766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85DB734-2502-4F58-9784-563C8E520A4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8107"/>
            <a:ext cx="3392708" cy="308661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378F6FF-29A0-4F7C-BC98-9CBAFF87EA3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2708" y="186772"/>
            <a:ext cx="4613988" cy="3209731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C905CA1-B1CC-483F-BDF0-739DAEA8810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6696" y="186772"/>
            <a:ext cx="3610947" cy="3209731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B4B61E2D-5A3F-4778-87FF-82B0D1584C80}"/>
              </a:ext>
            </a:extLst>
          </p:cNvPr>
          <p:cNvSpPr txBox="1"/>
          <p:nvPr/>
        </p:nvSpPr>
        <p:spPr>
          <a:xfrm>
            <a:off x="1194318" y="4823927"/>
            <a:ext cx="962089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2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 pathway enrichment analysis for the candidate genes in the overlapped improvement and selection outliers detected between different geographical sources i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olitoriu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F3D4C43-47B5-4339-AF01-B2753325753E}"/>
              </a:ext>
            </a:extLst>
          </p:cNvPr>
          <p:cNvSpPr txBox="1"/>
          <p:nvPr/>
        </p:nvSpPr>
        <p:spPr>
          <a:xfrm>
            <a:off x="1247307" y="3583276"/>
            <a:ext cx="10370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component                                        molecular function                                         biological proces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62127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0FC81316-8FB7-4C88-8F65-A7B1DD26A3B9}"/>
              </a:ext>
            </a:extLst>
          </p:cNvPr>
          <p:cNvSpPr txBox="1"/>
          <p:nvPr/>
        </p:nvSpPr>
        <p:spPr>
          <a:xfrm>
            <a:off x="1744825" y="461137"/>
            <a:ext cx="81117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-C heatmap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capsularis (Cc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olitoriu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150 kb resolution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A529B19E-A21F-43B5-9E79-4EEA3ABBA9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7468" y="1259633"/>
            <a:ext cx="9610871" cy="45253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07141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15DB7CE2-6A48-494A-B3EB-0980938532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0133" y="560017"/>
            <a:ext cx="7540138" cy="5570015"/>
          </a:xfrm>
          <a:prstGeom prst="rect">
            <a:avLst/>
          </a:prstGeom>
        </p:spPr>
      </p:pic>
      <p:sp>
        <p:nvSpPr>
          <p:cNvPr id="5" name="TextBox 6">
            <a:extLst>
              <a:ext uri="{FF2B5EF4-FFF2-40B4-BE49-F238E27FC236}">
                <a16:creationId xmlns:a16="http://schemas.microsoft.com/office/drawing/2014/main" id="{AA532399-FFA0-43AB-A14F-8DD884623C45}"/>
              </a:ext>
            </a:extLst>
          </p:cNvPr>
          <p:cNvSpPr txBox="1"/>
          <p:nvPr/>
        </p:nvSpPr>
        <p:spPr>
          <a:xfrm>
            <a:off x="5387890" y="2144696"/>
            <a:ext cx="646820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 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timation of the LTR burst time based on intact LTRs identified by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TR_retriever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5490430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6814C5B-EFAF-4C78-B3AB-7513AA0EE93E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0342" y="578497"/>
            <a:ext cx="5677898" cy="5439747"/>
          </a:xfrm>
          <a:prstGeom prst="rect">
            <a:avLst/>
          </a:prstGeom>
        </p:spPr>
      </p:pic>
      <p:sp>
        <p:nvSpPr>
          <p:cNvPr id="5" name="TextBox 6">
            <a:extLst>
              <a:ext uri="{FF2B5EF4-FFF2-40B4-BE49-F238E27FC236}">
                <a16:creationId xmlns:a16="http://schemas.microsoft.com/office/drawing/2014/main" id="{B9E0C05A-5DDB-4C31-94D2-C1A7253BE9E0}"/>
              </a:ext>
            </a:extLst>
          </p:cNvPr>
          <p:cNvSpPr txBox="1"/>
          <p:nvPr/>
        </p:nvSpPr>
        <p:spPr>
          <a:xfrm>
            <a:off x="5723793" y="671132"/>
            <a:ext cx="646820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catter diagram of Ka (non-synonymous) and Ks (synonymous) nucleotide substitution rations among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pulari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olitoriu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s well as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ssypium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imondii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37401147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6">
            <a:extLst>
              <a:ext uri="{FF2B5EF4-FFF2-40B4-BE49-F238E27FC236}">
                <a16:creationId xmlns:a16="http://schemas.microsoft.com/office/drawing/2014/main" id="{09E96F96-1F57-4053-9CAB-C9FE463FC818}"/>
              </a:ext>
            </a:extLst>
          </p:cNvPr>
          <p:cNvSpPr txBox="1"/>
          <p:nvPr/>
        </p:nvSpPr>
        <p:spPr>
          <a:xfrm>
            <a:off x="6875411" y="643140"/>
            <a:ext cx="408805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</a:p>
          <a:p>
            <a:pPr algn="just"/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thenic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betwee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pularis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olitoriu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3C36C3F2-9F91-439B-84D8-25454F7F6A1C}"/>
              </a:ext>
            </a:extLst>
          </p:cNvPr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55780" y="536174"/>
            <a:ext cx="5722931" cy="57856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2172165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6">
            <a:extLst>
              <a:ext uri="{FF2B5EF4-FFF2-40B4-BE49-F238E27FC236}">
                <a16:creationId xmlns:a16="http://schemas.microsoft.com/office/drawing/2014/main" id="{0826DC77-54AA-4CB8-BCE6-041404E4CA57}"/>
              </a:ext>
            </a:extLst>
          </p:cNvPr>
          <p:cNvSpPr txBox="1"/>
          <p:nvPr/>
        </p:nvSpPr>
        <p:spPr>
          <a:xfrm>
            <a:off x="3083228" y="587156"/>
            <a:ext cx="646820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pathway enrichment analysis of genes located in the inversions betwee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pularis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olitoriu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922C970-9310-4B16-98D8-16F66DAEEC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46760"/>
            <a:ext cx="12192000" cy="46947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550537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6">
            <a:extLst>
              <a:ext uri="{FF2B5EF4-FFF2-40B4-BE49-F238E27FC236}">
                <a16:creationId xmlns:a16="http://schemas.microsoft.com/office/drawing/2014/main" id="{0826DC77-54AA-4CB8-BCE6-041404E4CA57}"/>
              </a:ext>
            </a:extLst>
          </p:cNvPr>
          <p:cNvSpPr txBox="1"/>
          <p:nvPr/>
        </p:nvSpPr>
        <p:spPr>
          <a:xfrm>
            <a:off x="8621994" y="1416909"/>
            <a:ext cx="323410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ic GO enrichment information of genes located in the inversions.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376A51CC-034A-4FC1-A6D1-8844CFE55E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94" y="0"/>
            <a:ext cx="85725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303589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287AE28-AA2E-4555-A7B4-10F31E59A5A6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425" y="373225"/>
            <a:ext cx="6363477" cy="5924939"/>
          </a:xfrm>
          <a:prstGeom prst="rect">
            <a:avLst/>
          </a:prstGeom>
          <a:noFill/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D17F641-5A52-45D1-9DA6-4144D5CE34BB}"/>
              </a:ext>
            </a:extLst>
          </p:cNvPr>
          <p:cNvSpPr txBox="1"/>
          <p:nvPr/>
        </p:nvSpPr>
        <p:spPr>
          <a:xfrm>
            <a:off x="7632441" y="1735494"/>
            <a:ext cx="405881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hylogeny of cellulose synthase (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s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cellulose synthase-like (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sl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genes in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zh-CN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pulari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olitoriu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thalian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ifferent color circles indicated differential expression between leaves.60d and stem-bark.60d. Red circles mean up-regulation at stem-bark.60d, while blue ones indicate up-regulation at leaves.60d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2062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26</TotalTime>
  <Words>961</Words>
  <Application>Microsoft Office PowerPoint</Application>
  <PresentationFormat>宽屏</PresentationFormat>
  <Paragraphs>116</Paragraphs>
  <Slides>22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2</vt:i4>
      </vt:variant>
    </vt:vector>
  </HeadingPairs>
  <TitlesOfParts>
    <vt:vector size="30" baseType="lpstr">
      <vt:lpstr>等线</vt:lpstr>
      <vt:lpstr>等线 Light</vt:lpstr>
      <vt:lpstr>宋体</vt:lpstr>
      <vt:lpstr>微软雅黑</vt:lpstr>
      <vt:lpstr>Arial</vt:lpstr>
      <vt:lpstr>Calibri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xk</dc:creator>
  <cp:lastModifiedBy>Administrator</cp:lastModifiedBy>
  <cp:revision>709</cp:revision>
  <dcterms:created xsi:type="dcterms:W3CDTF">2018-06-05T12:50:17Z</dcterms:created>
  <dcterms:modified xsi:type="dcterms:W3CDTF">2021-05-09T06:47:25Z</dcterms:modified>
</cp:coreProperties>
</file>